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08"/>
    <p:restoredTop sz="94569"/>
  </p:normalViewPr>
  <p:slideViewPr>
    <p:cSldViewPr snapToGrid="0" snapToObjects="1">
      <p:cViewPr>
        <p:scale>
          <a:sx n="90" d="100"/>
          <a:sy n="90" d="100"/>
        </p:scale>
        <p:origin x="928" y="3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1988F0-5DD9-E649-85FD-D244E317DF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BAD60D-4D41-9745-8160-CD3CDB022C7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B87841-442C-B545-8729-E9EF4590D0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F7B403-4E0A-3F45-957E-D66C19994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444354-422E-A945-ACC6-8BB47D6B4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844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6F8FB6-D848-0B43-883D-4B0F3CC9C5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E99929-88D9-7F41-87F6-96FE5CB480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03916-7F3D-B040-987D-7840C20A24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9DE1E-15D9-1141-8438-2773902A5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8A7C18-177C-F546-92B4-DD30F8B164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391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A1B3DA4-3FF2-134C-B6F9-6AD45DEC5D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79D9372-0A0B-894F-8BA1-B4F22378ED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7FC3ED-1EA0-F240-B8CC-8CE128D92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2C1D0-2B31-3749-978A-64E7A9419C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69DB996-0589-544D-93D5-FB296F5CF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0593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93A612-AE42-DF45-BCE4-085DF41AF6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831AEF-5688-7D4B-8D2E-8F9D1071AA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735A62-A1EF-D145-A0B9-41CA2237EF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F5BC7C-CAA8-5F4C-B764-D722AB3BEC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1CC3E6-5007-F14A-AE2C-4E7E84EAE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0575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94B86-D98C-5249-89F9-05EFAEA1EA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A96A16D-BCC1-CC4C-9479-FFAC7CFEC0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BAA5BF-8BE8-6A47-AB40-E2E8A84A14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EB29459-D8FB-0E47-B7EC-BA2928A999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AD5A82-8F14-B940-BDC9-392B86396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3207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0DC7AA-0805-E14F-9921-491A4366D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73FC71B-BF72-F64D-99D7-0EEE79CE8C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DAE3B1-457E-2D4D-9A7F-660F856E64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A8738A-E4C1-554B-AA8F-3819847A8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60D17-E2B3-0A42-BC01-DDA7CFAFC2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D7F8C7-C4BC-8949-AEF8-9522E7F51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192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D4551A-8004-1149-9B2E-AC8617E8E8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D50E9F-0364-6843-A950-E4E0998234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C3C393-0FF7-A04E-BCE5-E5A5B5BDDF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640FBF-D0B7-0947-8CD4-7D9D5DCEF5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0C867C2-873B-704C-BE9F-BDE88399EC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8985922-1501-0741-9544-6850FD6B3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D1DC445-F0B5-964A-89F0-302EA855A9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7A60F09-C18A-5D4A-855F-BC88AA2385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38066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81BF2A-5738-3C4B-9EC3-F45702579A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A38CFF3-0B5D-1549-A462-E8C490908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E3C20F-B638-F948-A339-DD9BECFF7A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BC9774-65AB-3141-9A01-B572D52745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91473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AD5CBCC-BF9F-BB49-9B41-3DB06186B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E7086-D0BB-EB40-AF96-797F11657B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E5BF33-DBEC-674D-8159-5A5F93AAB0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2175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09B42F-4A57-8C41-94DE-38C416BC1E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B05C94-66D2-624E-A452-8E4A36FEEE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0271A3-DA61-1548-A7B1-22E788C499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59FFE2-3889-BD47-80DD-D4E62B216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4FF0EF-0767-EA45-B6A2-B73EFD8112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E6461EE-898C-B046-87E9-93B7BC6DC9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2546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98B96F-5F99-6540-A16F-8740724AF7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2B49829-064B-674D-9CEF-FED7993674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6AD0A4-1A05-644C-A3D9-2686BB12B2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B47729-7701-9C44-8ACD-AC51D36F3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2D53B4-9C8E-C04F-B59E-83ABBD8716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DEC7D0-7B49-ED4E-9304-2CF03DE0CE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0366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68288D-97FE-C045-A0E5-F1D242551C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C62942-2B3D-564E-9849-F7F806FD6C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ABA9E2-7AB7-714D-AF06-22599FACBFB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28F253-5682-414E-8E40-631DCCE26ADA}" type="datetimeFigureOut">
              <a:rPr lang="en-US" smtClean="0"/>
              <a:t>4/23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451D4B-1B56-5A4D-B515-76B54A872C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1D2B82-7372-8444-9DA2-C4748F4CF1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CBB500-6033-4344-B97E-6FB8B5345BE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2662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E0F630-329F-9E4B-90B2-896A722844A3}"/>
              </a:ext>
            </a:extLst>
          </p:cNvPr>
          <p:cNvSpPr txBox="1"/>
          <p:nvPr/>
        </p:nvSpPr>
        <p:spPr>
          <a:xfrm>
            <a:off x="3945392" y="759126"/>
            <a:ext cx="409176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3200" b="1" dirty="0"/>
              <a:t>Supplementary Figure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BE48AE7-E29F-4042-997E-0D78C28997FC}"/>
              </a:ext>
            </a:extLst>
          </p:cNvPr>
          <p:cNvSpPr txBox="1"/>
          <p:nvPr/>
        </p:nvSpPr>
        <p:spPr>
          <a:xfrm>
            <a:off x="1195477" y="1880700"/>
            <a:ext cx="9591590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200" b="1" dirty="0"/>
              <a:t>A chromosome-level reference genome assembly and a full-length transcriptome assembly of the giant freshwater prawn (</a:t>
            </a:r>
            <a:r>
              <a:rPr lang="en-US" sz="2200" b="1" i="1" dirty="0" err="1"/>
              <a:t>Macrobrachium</a:t>
            </a:r>
            <a:r>
              <a:rPr lang="en-US" sz="2200" b="1" i="1" dirty="0"/>
              <a:t> </a:t>
            </a:r>
            <a:r>
              <a:rPr lang="en-US" sz="2200" b="1" i="1" dirty="0" err="1"/>
              <a:t>rosenbergii</a:t>
            </a:r>
            <a:r>
              <a:rPr lang="en-US" sz="2200" b="1" dirty="0"/>
              <a:t>) </a:t>
            </a:r>
            <a:r>
              <a:rPr lang="en-US" sz="2200" dirty="0"/>
              <a:t> </a:t>
            </a:r>
          </a:p>
          <a:p>
            <a:endParaRPr lang="en-US" dirty="0"/>
          </a:p>
          <a:p>
            <a:r>
              <a:rPr lang="en-US" dirty="0" err="1"/>
              <a:t>Wirulda</a:t>
            </a:r>
            <a:r>
              <a:rPr lang="en-US" dirty="0"/>
              <a:t> Pootakham</a:t>
            </a:r>
            <a:r>
              <a:rPr lang="en-US" baseline="30000" dirty="0"/>
              <a:t>1,*</a:t>
            </a:r>
            <a:r>
              <a:rPr lang="en-US" dirty="0"/>
              <a:t>, Kanchana Sittikankaew</a:t>
            </a:r>
            <a:r>
              <a:rPr lang="en-US" baseline="30000" dirty="0"/>
              <a:t>1,†</a:t>
            </a:r>
            <a:r>
              <a:rPr lang="en-US" dirty="0"/>
              <a:t>,</a:t>
            </a:r>
            <a:r>
              <a:rPr lang="en-US" b="1" dirty="0"/>
              <a:t> </a:t>
            </a:r>
            <a:r>
              <a:rPr lang="en-US" b="1" baseline="30000" dirty="0"/>
              <a:t> </a:t>
            </a:r>
            <a:r>
              <a:rPr lang="en-US" dirty="0" err="1"/>
              <a:t>Chutima</a:t>
            </a:r>
            <a:r>
              <a:rPr lang="en-US" dirty="0"/>
              <a:t> Sonthirod</a:t>
            </a:r>
            <a:r>
              <a:rPr lang="en-US" baseline="30000" dirty="0"/>
              <a:t>1,†</a:t>
            </a:r>
            <a:r>
              <a:rPr lang="en-US" dirty="0"/>
              <a:t>, </a:t>
            </a:r>
            <a:r>
              <a:rPr lang="en-US" dirty="0" err="1"/>
              <a:t>Chaiwat</a:t>
            </a:r>
            <a:r>
              <a:rPr lang="en-US" dirty="0"/>
              <a:t> Naktang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Tanaporn</a:t>
            </a:r>
            <a:r>
              <a:rPr lang="en-US" dirty="0"/>
              <a:t> Uengwetwanit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Wasitthee</a:t>
            </a:r>
            <a:r>
              <a:rPr lang="en-US" dirty="0"/>
              <a:t> Kongkachana</a:t>
            </a:r>
            <a:r>
              <a:rPr lang="en-US" baseline="30000" dirty="0"/>
              <a:t>1</a:t>
            </a:r>
            <a:r>
              <a:rPr lang="en-US" dirty="0"/>
              <a:t>, </a:t>
            </a:r>
            <a:r>
              <a:rPr lang="en-US" dirty="0" err="1"/>
              <a:t>Kongphop</a:t>
            </a:r>
            <a:r>
              <a:rPr lang="en-US" dirty="0"/>
              <a:t> Ampolsak</a:t>
            </a:r>
            <a:r>
              <a:rPr lang="en-US" baseline="30000" dirty="0"/>
              <a:t>2</a:t>
            </a:r>
            <a:r>
              <a:rPr lang="en-US" dirty="0"/>
              <a:t>, </a:t>
            </a:r>
            <a:r>
              <a:rPr lang="en-US" dirty="0" err="1"/>
              <a:t>Nitsara</a:t>
            </a:r>
            <a:r>
              <a:rPr lang="en-US" dirty="0"/>
              <a:t> Karoonuthaisiri</a:t>
            </a:r>
            <a:r>
              <a:rPr lang="en-US" baseline="30000" dirty="0"/>
              <a:t>1,3,4</a:t>
            </a:r>
            <a:endParaRPr lang="en-TH"/>
          </a:p>
          <a:p>
            <a:r>
              <a:rPr lang="en-US" sz="1200" dirty="0"/>
              <a:t> </a:t>
            </a:r>
          </a:p>
          <a:p>
            <a:r>
              <a:rPr lang="en-US" sz="1400" baseline="30000" dirty="0"/>
              <a:t>1</a:t>
            </a:r>
            <a:r>
              <a:rPr lang="en-US" sz="1400" dirty="0"/>
              <a:t>National Center for Genetic Engineering and Biotechnology (BIOTEC), National Science and Technology Development Agency (NSTDA), </a:t>
            </a:r>
            <a:r>
              <a:rPr lang="en-US" sz="1400" dirty="0" err="1"/>
              <a:t>Pathum</a:t>
            </a:r>
            <a:r>
              <a:rPr lang="en-US" sz="1400" dirty="0"/>
              <a:t> Thani, Thailand.</a:t>
            </a:r>
            <a:endParaRPr lang="en-TH" sz="1400"/>
          </a:p>
          <a:p>
            <a:r>
              <a:rPr lang="en-US" sz="1400" baseline="30000" dirty="0"/>
              <a:t>2</a:t>
            </a:r>
            <a:r>
              <a:rPr lang="en-US" sz="1400" dirty="0"/>
              <a:t>Pathum Thani Aquatic Animal Genetics Research and Development Center Aquatic Animal Genetics Research and Development Division, Department of Fisheries Ministry of Agriculture and Cooperatives, </a:t>
            </a:r>
            <a:r>
              <a:rPr lang="en-US" sz="1400" dirty="0" err="1"/>
              <a:t>Pathum</a:t>
            </a:r>
            <a:r>
              <a:rPr lang="en-US" sz="1400" dirty="0"/>
              <a:t> Thani, 12120, Thailand</a:t>
            </a:r>
            <a:r>
              <a:rPr lang="th-TH" sz="1400" dirty="0"/>
              <a:t>.</a:t>
            </a:r>
            <a:endParaRPr lang="en-TH" sz="1400"/>
          </a:p>
          <a:p>
            <a:r>
              <a:rPr lang="en-US" sz="1400" baseline="30000" dirty="0"/>
              <a:t>3</a:t>
            </a:r>
            <a:r>
              <a:rPr lang="en-US" sz="1400" dirty="0"/>
              <a:t>International Joint Research Center on Food Security, 113 Thailand Science Park, </a:t>
            </a:r>
            <a:r>
              <a:rPr lang="en-US" sz="1400" dirty="0" err="1"/>
              <a:t>Phahonyothin</a:t>
            </a:r>
            <a:r>
              <a:rPr lang="en-US" sz="1400" dirty="0"/>
              <a:t> Road, Khlong </a:t>
            </a:r>
            <a:r>
              <a:rPr lang="en-US" sz="1400" dirty="0" err="1"/>
              <a:t>Nueng</a:t>
            </a:r>
            <a:r>
              <a:rPr lang="en-US" sz="1400" dirty="0"/>
              <a:t>, Khlong </a:t>
            </a:r>
            <a:r>
              <a:rPr lang="en-US" sz="1400" dirty="0" err="1"/>
              <a:t>Luang</a:t>
            </a:r>
            <a:r>
              <a:rPr lang="en-US" sz="1400" dirty="0"/>
              <a:t>, </a:t>
            </a:r>
            <a:r>
              <a:rPr lang="en-US" sz="1400" dirty="0" err="1"/>
              <a:t>Pathum</a:t>
            </a:r>
            <a:r>
              <a:rPr lang="en-US" sz="1400" dirty="0"/>
              <a:t> Thani 12120 Thailand</a:t>
            </a:r>
            <a:endParaRPr lang="en-TH" sz="1400"/>
          </a:p>
          <a:p>
            <a:r>
              <a:rPr lang="en-US" sz="1400" baseline="30000" dirty="0"/>
              <a:t>4</a:t>
            </a:r>
            <a:r>
              <a:rPr lang="en-US" sz="1400" dirty="0"/>
              <a:t>Institute for Global Food Security, Queen's University, Belfast, Biological Sciences Building, 19 Chlorine Gardens, Belfast, BT9 5DL, United Kingdom</a:t>
            </a:r>
            <a:endParaRPr lang="en-TH" sz="1400"/>
          </a:p>
          <a:p>
            <a:r>
              <a:rPr lang="en-US" sz="1200" dirty="0"/>
              <a:t> </a:t>
            </a:r>
          </a:p>
          <a:p>
            <a:r>
              <a:rPr lang="en-US" dirty="0"/>
              <a:t>*Corresponding authors</a:t>
            </a:r>
            <a:endParaRPr lang="en-TH"/>
          </a:p>
          <a:p>
            <a:r>
              <a:rPr lang="en-US" dirty="0" err="1"/>
              <a:t>Wirulda</a:t>
            </a:r>
            <a:r>
              <a:rPr lang="en-US" dirty="0"/>
              <a:t> </a:t>
            </a:r>
            <a:r>
              <a:rPr lang="en-US" dirty="0" err="1"/>
              <a:t>Pootakham</a:t>
            </a:r>
            <a:r>
              <a:rPr lang="en-US" dirty="0"/>
              <a:t> (</a:t>
            </a:r>
            <a:r>
              <a:rPr lang="en-US" dirty="0" err="1"/>
              <a:t>wirulda@alumni.stanford.edu</a:t>
            </a:r>
            <a:r>
              <a:rPr lang="en-US" dirty="0"/>
              <a:t>)</a:t>
            </a:r>
            <a:r>
              <a:rPr lang="en-US" sz="1200" b="1" dirty="0"/>
              <a:t> 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392799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04812C46-200A-4DEB-A05E-3ED6C68C2387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049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D1EA859B-E555-4109-94F3-6700E046E00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-1" y="0"/>
            <a:ext cx="7390263" cy="6858000"/>
          </a:xfrm>
          <a:prstGeom prst="rect">
            <a:avLst/>
          </a:prstGeom>
          <a:gradFill>
            <a:gsLst>
              <a:gs pos="48000">
                <a:schemeClr val="bg1"/>
              </a:gs>
              <a:gs pos="35000">
                <a:schemeClr val="bg1">
                  <a:alpha val="77000"/>
                </a:schemeClr>
              </a:gs>
              <a:gs pos="19000">
                <a:schemeClr val="bg1">
                  <a:alpha val="3800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10800000" scaled="0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E701FB-DB91-BE40-9DD7-D0D4886B03B0}"/>
              </a:ext>
            </a:extLst>
          </p:cNvPr>
          <p:cNvSpPr txBox="1"/>
          <p:nvPr/>
        </p:nvSpPr>
        <p:spPr>
          <a:xfrm>
            <a:off x="616866" y="6078670"/>
            <a:ext cx="11057392" cy="635281"/>
          </a:xfrm>
          <a:prstGeom prst="rect">
            <a:avLst/>
          </a:prstGeom>
        </p:spPr>
        <p:txBody>
          <a:bodyPr vert="horz" lIns="91440" tIns="45720" rIns="91440" bIns="45720" rtlCol="0">
            <a:normAutofit lnSpcReduction="10000"/>
          </a:bodyPr>
          <a:lstStyle/>
          <a:p>
            <a:pPr>
              <a:lnSpc>
                <a:spcPct val="90000"/>
              </a:lnSpc>
              <a:spcAft>
                <a:spcPts val="600"/>
              </a:spcAft>
            </a:pPr>
            <a:r>
              <a:rPr lang="en-US" sz="2000" b="1" dirty="0"/>
              <a:t>Supplementary Figure S1. </a:t>
            </a:r>
            <a:r>
              <a:rPr lang="en-US" sz="2000" dirty="0"/>
              <a:t>Pictures of the giant river prawn displaying different sexes and morphotypes: (A) a female bearing eggs (B) an orange-claw male (C) a blue-claw male.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1352902-2B94-264D-B3AB-9923E6D2A1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3546" y="196123"/>
            <a:ext cx="8107957" cy="5686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16575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9B58228D-1990-134E-8926-A9E58CE73072}"/>
              </a:ext>
            </a:extLst>
          </p:cNvPr>
          <p:cNvSpPr txBox="1"/>
          <p:nvPr/>
        </p:nvSpPr>
        <p:spPr>
          <a:xfrm>
            <a:off x="578001" y="5908067"/>
            <a:ext cx="1129667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ry Figure S2. </a:t>
            </a:r>
            <a:r>
              <a:rPr lang="en-US" sz="2000" dirty="0"/>
              <a:t>Hi-C interaction matrix maps of </a:t>
            </a:r>
            <a:r>
              <a:rPr lang="en-US" sz="2000" i="1" dirty="0"/>
              <a:t>M. </a:t>
            </a:r>
            <a:r>
              <a:rPr lang="en-US" sz="2000" i="1" dirty="0" err="1"/>
              <a:t>rosenbergii</a:t>
            </a:r>
            <a:r>
              <a:rPr lang="en-US" sz="2000" i="1" dirty="0"/>
              <a:t> </a:t>
            </a:r>
            <a:r>
              <a:rPr lang="en-US" sz="2000" dirty="0"/>
              <a:t>chromosomes. The contact density is indicated by the color scale on the right from dark red (high density) to white (low density). 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971E5AA-E88F-BC41-8DC9-B87BF31254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95247" y="45886"/>
            <a:ext cx="5862181" cy="5862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80549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DA632F3-7022-C54D-A6F1-AFC491A73F74}"/>
              </a:ext>
            </a:extLst>
          </p:cNvPr>
          <p:cNvSpPr txBox="1"/>
          <p:nvPr/>
        </p:nvSpPr>
        <p:spPr>
          <a:xfrm>
            <a:off x="807892" y="6324725"/>
            <a:ext cx="1116698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upplementary Figure S3. </a:t>
            </a:r>
            <a:r>
              <a:rPr lang="en-US" sz="2000" dirty="0"/>
              <a:t>Gene Ontology (GO) annotation of </a:t>
            </a:r>
            <a:r>
              <a:rPr lang="en-US" sz="2000" i="1" dirty="0"/>
              <a:t>M. </a:t>
            </a:r>
            <a:r>
              <a:rPr lang="en-US" sz="2000" i="1" dirty="0" err="1"/>
              <a:t>rosenbergii</a:t>
            </a:r>
            <a:r>
              <a:rPr lang="en-US" sz="2000" i="1" dirty="0"/>
              <a:t> </a:t>
            </a:r>
            <a:r>
              <a:rPr lang="en-US" sz="2000" dirty="0"/>
              <a:t>genes in the assembly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16C1427-4F71-CF48-AED5-44C8C6DF84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5597" y="187890"/>
            <a:ext cx="8516037" cy="6025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70094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1</TotalTime>
  <Words>265</Words>
  <Application>Microsoft Macintosh PowerPoint</Application>
  <PresentationFormat>Widescreen</PresentationFormat>
  <Paragraphs>1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Cordia New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rulda Pootakham</dc:creator>
  <cp:lastModifiedBy>Wirulda Pootakham</cp:lastModifiedBy>
  <cp:revision>11</cp:revision>
  <dcterms:created xsi:type="dcterms:W3CDTF">2024-03-11T08:06:58Z</dcterms:created>
  <dcterms:modified xsi:type="dcterms:W3CDTF">2024-04-23T05:56:40Z</dcterms:modified>
</cp:coreProperties>
</file>